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C66C8D-EA21-4287-86FF-05145ACE16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E78DE-7F3C-425C-972F-B4CC24AC4D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32FD4-F556-4865-8B10-ADAA7F0106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8C7A46-B1D4-4FAD-805A-411B669D9C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873EF8-DC09-4DEC-9C70-DB3E44EFCE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4C9807-CABF-43D7-9891-F8F563EFDA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66A449-5DC5-49BB-9C00-7F6F317B55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3D4A3F-8677-4CCD-85C9-3D9221ABC7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87A46-7544-420F-95D2-A9450217EB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E6A407-9FB0-4E95-BDB9-2E9A34C7B2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21178-D69D-48C7-8C54-F57C9FFF1A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469C9-0B43-4AF0-9A57-0B1E8DDFD0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B65A2B-DC66-4A11-BC9C-81A84235D07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324160" y="2457360"/>
            <a:ext cx="2652480" cy="26002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514600" y="5257800"/>
            <a:ext cx="2438280" cy="58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i="1" lang="en-US" sz="1600" spc="-1" strike="noStrike" baseline="-25000">
                <a:solidFill>
                  <a:srgbClr val="000000"/>
                </a:solidFill>
                <a:latin typeface="Times New Roman"/>
              </a:rPr>
              <a:t>i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) estimated from “NIA ES Bank, 53 genes”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6200000">
            <a:off x="485640" y="3552840"/>
            <a:ext cx="2355840" cy="58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i="1" lang="en-US" sz="1600" spc="-1" strike="noStrike" baseline="-25000">
                <a:solidFill>
                  <a:srgbClr val="000000"/>
                </a:solidFill>
                <a:latin typeface="Times New Roman"/>
              </a:rPr>
              <a:t>i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) estimated from “NIA Other perturbations”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319480" y="5089680"/>
            <a:ext cx="0" cy="55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989440" y="5089680"/>
            <a:ext cx="0" cy="55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656160" y="5089680"/>
            <a:ext cx="0" cy="55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322880" y="5089680"/>
            <a:ext cx="0" cy="55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989600" y="5089680"/>
            <a:ext cx="0" cy="55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214000" y="505764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214000" y="441000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214000" y="375912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214000" y="311292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214000" y="246204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141280" y="5135400"/>
            <a:ext cx="35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1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761200" y="5135400"/>
            <a:ext cx="35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447000" y="5135400"/>
            <a:ext cx="35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0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150440" y="5135400"/>
            <a:ext cx="35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817880" y="513540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1887120" y="4918680"/>
            <a:ext cx="35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1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1852560" y="4287600"/>
            <a:ext cx="40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rot="16200000">
            <a:off x="1888920" y="3651840"/>
            <a:ext cx="35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0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6200000">
            <a:off x="1888920" y="3007440"/>
            <a:ext cx="35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6200000">
            <a:off x="1918080" y="23788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265480" y="2394000"/>
            <a:ext cx="2752560" cy="2695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868120" y="2423520"/>
            <a:ext cx="21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굴림"/>
              </a:rPr>
              <a:t>r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굴림"/>
              </a:rPr>
              <a:t> = 0.614, t = 106.2, p&lt;0.00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828720" y="6735600"/>
            <a:ext cx="5411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굴림"/>
              </a:rPr>
              <a:t>Additional File 5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굴림"/>
              </a:rPr>
              <a:t> Comparison of TF-responsiveness estimated from two databases: “NIA ES Bank, 53 genes”, and “NIA Other Perturbations”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28T20:23:48Z</dcterms:created>
  <dc:creator>Alexei Sharov</dc:creator>
  <dc:description/>
  <dc:language>en-US</dc:language>
  <cp:lastModifiedBy>Alexei Sharov</cp:lastModifiedBy>
  <dcterms:modified xsi:type="dcterms:W3CDTF">2011-01-28T20:36:21Z</dcterms:modified>
  <cp:revision>2</cp:revision>
  <dc:subject/>
  <dc:title>Slide 1</dc:title>
</cp:coreProperties>
</file>